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540" r:id="rId2"/>
    <p:sldId id="259" r:id="rId3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8000"/>
    <a:srgbClr val="CC0099"/>
    <a:srgbClr val="800080"/>
    <a:srgbClr val="0000FF"/>
    <a:srgbClr val="00CC00"/>
    <a:srgbClr val="FFFF00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110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755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C90DA38-6E1A-47ED-9D4B-95415940CA63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9D7CC4B-6A92-4A23-900B-F8BD6EFE4E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82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745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453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042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948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822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284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293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31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10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911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257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BB64A3-12BF-4111-8DF4-9B9B503EA4ED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9BAAD-5EB0-4405-B46D-FE1913D3B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283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7BA9C30D-9806-0AC4-1B32-B240A5600BC2}"/>
              </a:ext>
            </a:extLst>
          </p:cNvPr>
          <p:cNvGrpSpPr/>
          <p:nvPr/>
        </p:nvGrpSpPr>
        <p:grpSpPr>
          <a:xfrm>
            <a:off x="-176" y="-40695"/>
            <a:ext cx="9053651" cy="6860608"/>
            <a:chOff x="-176" y="-90799"/>
            <a:chExt cx="9053651" cy="6860608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D5C4D30-04C9-10F3-91BA-31DF2FC38434}"/>
                </a:ext>
              </a:extLst>
            </p:cNvPr>
            <p:cNvSpPr txBox="1"/>
            <p:nvPr/>
          </p:nvSpPr>
          <p:spPr>
            <a:xfrm>
              <a:off x="-176" y="-90799"/>
              <a:ext cx="238012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800"/>
                </a:spcAft>
              </a:pPr>
              <a:r>
                <a:rPr lang="en-US" sz="16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l </a:t>
              </a:r>
              <a:r>
                <a:rPr lang="en-US" sz="1600" b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</a:t>
              </a:r>
              <a:r>
                <a:rPr lang="en-US" sz="16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g. 1</a:t>
              </a:r>
              <a:endPara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C164EA84-6DFC-55FF-25E4-51B9E0963D0D}"/>
                </a:ext>
              </a:extLst>
            </p:cNvPr>
            <p:cNvGrpSpPr/>
            <p:nvPr/>
          </p:nvGrpSpPr>
          <p:grpSpPr>
            <a:xfrm>
              <a:off x="14617" y="4549029"/>
              <a:ext cx="8991596" cy="2220780"/>
              <a:chOff x="14617" y="352819"/>
              <a:chExt cx="8991596" cy="222078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DBCE44B1-E08C-7256-0D69-B45CE3347A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1853"/>
              <a:stretch/>
            </p:blipFill>
            <p:spPr>
              <a:xfrm>
                <a:off x="6021976" y="436004"/>
                <a:ext cx="2157521" cy="1787202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B6FE876C-B2F0-FB74-8EC0-A3F1FEAE96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2215"/>
              <a:stretch/>
            </p:blipFill>
            <p:spPr>
              <a:xfrm>
                <a:off x="621109" y="443578"/>
                <a:ext cx="2159670" cy="1867296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B3CB79EA-91EC-2237-E4A8-FCB48A3128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821"/>
              <a:stretch/>
            </p:blipFill>
            <p:spPr>
              <a:xfrm>
                <a:off x="3413608" y="425894"/>
                <a:ext cx="2198052" cy="1846741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EBF0615-712E-BACD-21C4-7909A7D3DDD3}"/>
                  </a:ext>
                </a:extLst>
              </p:cNvPr>
              <p:cNvSpPr txBox="1"/>
              <p:nvPr/>
            </p:nvSpPr>
            <p:spPr>
              <a:xfrm rot="16200000">
                <a:off x="179763" y="1483507"/>
                <a:ext cx="68754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VD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DC367F6E-B650-9569-8875-5F83A7D84C5E}"/>
                  </a:ext>
                </a:extLst>
              </p:cNvPr>
              <p:cNvSpPr txBox="1"/>
              <p:nvPr/>
            </p:nvSpPr>
            <p:spPr>
              <a:xfrm>
                <a:off x="766534" y="2230929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29A43E9-31DE-8D9C-8D38-D4F1E0EB2E2E}"/>
                  </a:ext>
                </a:extLst>
              </p:cNvPr>
              <p:cNvSpPr txBox="1"/>
              <p:nvPr/>
            </p:nvSpPr>
            <p:spPr>
              <a:xfrm rot="16200000">
                <a:off x="2908684" y="816505"/>
                <a:ext cx="79409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7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891BE2E-8C40-FB6B-B922-C4C0F9A423C3}"/>
                  </a:ext>
                </a:extLst>
              </p:cNvPr>
              <p:cNvSpPr txBox="1"/>
              <p:nvPr/>
            </p:nvSpPr>
            <p:spPr>
              <a:xfrm>
                <a:off x="3931794" y="2235045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8</a:t>
                </a:r>
              </a:p>
            </p:txBody>
          </p:sp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362EC93E-2B8A-2C2A-857A-FBF2FB0937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36651" y="1431867"/>
                <a:ext cx="1260389" cy="0"/>
              </a:xfrm>
              <a:prstGeom prst="straightConnector1">
                <a:avLst/>
              </a:prstGeom>
              <a:ln w="3492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7AE7F91-C75D-4BB7-3438-34B8B8AEBB3C}"/>
                  </a:ext>
                </a:extLst>
              </p:cNvPr>
              <p:cNvSpPr txBox="1"/>
              <p:nvPr/>
            </p:nvSpPr>
            <p:spPr>
              <a:xfrm rot="16200000">
                <a:off x="5655290" y="1331099"/>
                <a:ext cx="68754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A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DFD3AF2-0E2E-1FE9-E0EE-E9543542B2F4}"/>
                  </a:ext>
                </a:extLst>
              </p:cNvPr>
              <p:cNvSpPr txBox="1"/>
              <p:nvPr/>
            </p:nvSpPr>
            <p:spPr>
              <a:xfrm>
                <a:off x="6538626" y="2177376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M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8B8F1D03-4B2F-C675-6957-411CD3284041}"/>
                  </a:ext>
                </a:extLst>
              </p:cNvPr>
              <p:cNvSpPr txBox="1"/>
              <p:nvPr/>
            </p:nvSpPr>
            <p:spPr>
              <a:xfrm>
                <a:off x="8201322" y="1053186"/>
                <a:ext cx="804891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CD19+        </a:t>
                </a:r>
              </a:p>
              <a:p>
                <a:r>
                  <a:rPr lang="en-US" sz="1000" b="1" dirty="0"/>
                  <a:t>CD27+</a:t>
                </a:r>
              </a:p>
              <a:p>
                <a:r>
                  <a:rPr lang="en-US" sz="1000" b="1" dirty="0"/>
                  <a:t>IgA-</a:t>
                </a:r>
              </a:p>
              <a:p>
                <a:r>
                  <a:rPr lang="en-US" sz="1000" b="1" dirty="0"/>
                  <a:t>IgM-</a:t>
                </a:r>
              </a:p>
              <a:p>
                <a:r>
                  <a:rPr lang="en-US" sz="1000" b="1" dirty="0"/>
                  <a:t>CD38 Int</a:t>
                </a:r>
              </a:p>
            </p:txBody>
          </p:sp>
          <p:sp>
            <p:nvSpPr>
              <p:cNvPr id="15" name="Arrow: Left 14">
                <a:extLst>
                  <a:ext uri="{FF2B5EF4-FFF2-40B4-BE49-F238E27FC236}">
                    <a16:creationId xmlns:a16="http://schemas.microsoft.com/office/drawing/2014/main" id="{249C0FF4-6891-98DA-B86B-E453059172D1}"/>
                  </a:ext>
                </a:extLst>
              </p:cNvPr>
              <p:cNvSpPr/>
              <p:nvPr/>
            </p:nvSpPr>
            <p:spPr>
              <a:xfrm rot="19560000">
                <a:off x="7293842" y="977786"/>
                <a:ext cx="319846" cy="195308"/>
              </a:xfrm>
              <a:prstGeom prst="lef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46AA68BE-804E-9324-360A-3E2138052CC3}"/>
                  </a:ext>
                </a:extLst>
              </p:cNvPr>
              <p:cNvSpPr txBox="1"/>
              <p:nvPr/>
            </p:nvSpPr>
            <p:spPr>
              <a:xfrm>
                <a:off x="7572252" y="713217"/>
                <a:ext cx="114909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solidFill>
                      <a:srgbClr val="FF00FF"/>
                    </a:solidFill>
                  </a:rPr>
                  <a:t>IgG Mem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1C56912-B2B5-0647-FA0B-60F9C15B6C41}"/>
                  </a:ext>
                </a:extLst>
              </p:cNvPr>
              <p:cNvSpPr txBox="1"/>
              <p:nvPr/>
            </p:nvSpPr>
            <p:spPr>
              <a:xfrm>
                <a:off x="14617" y="352819"/>
                <a:ext cx="47598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91FB73E3-D057-7AB2-50DA-FA08B964E3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68367" y="1246065"/>
                <a:ext cx="1260389" cy="0"/>
              </a:xfrm>
              <a:prstGeom prst="straightConnector1">
                <a:avLst/>
              </a:prstGeom>
              <a:ln w="3492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6F62ED61-0148-6151-C35D-7BA714C31330}"/>
                </a:ext>
              </a:extLst>
            </p:cNvPr>
            <p:cNvGrpSpPr/>
            <p:nvPr/>
          </p:nvGrpSpPr>
          <p:grpSpPr>
            <a:xfrm>
              <a:off x="38865" y="175367"/>
              <a:ext cx="9014610" cy="4353773"/>
              <a:chOff x="38865" y="2517729"/>
              <a:chExt cx="9014610" cy="4353773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833CFF0F-C7F1-2400-C901-1FCCBD92BD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402308" y="2848009"/>
                <a:ext cx="1905266" cy="1733792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BEE64177-6BBF-7B00-C036-B11B7DCF01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3169"/>
              <a:stretch/>
            </p:blipFill>
            <p:spPr>
              <a:xfrm>
                <a:off x="4597047" y="2855934"/>
                <a:ext cx="1914792" cy="1724970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440D02C7-4E7C-8E29-36A5-9E84CDDF93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385948" y="4793543"/>
                <a:ext cx="2086266" cy="1895740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CF1E5836-2C05-2544-4F9D-4DBEF81BA5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660"/>
              <a:stretch/>
            </p:blipFill>
            <p:spPr>
              <a:xfrm>
                <a:off x="6746837" y="2768249"/>
                <a:ext cx="1962424" cy="1731817"/>
              </a:xfrm>
              <a:prstGeom prst="rect">
                <a:avLst/>
              </a:prstGeom>
            </p:spPr>
          </p:pic>
          <p:sp>
            <p:nvSpPr>
              <p:cNvPr id="24" name="Arrow: Left 23">
                <a:extLst>
                  <a:ext uri="{FF2B5EF4-FFF2-40B4-BE49-F238E27FC236}">
                    <a16:creationId xmlns:a16="http://schemas.microsoft.com/office/drawing/2014/main" id="{032D2F34-E54E-E95B-F5B7-273F767E3769}"/>
                  </a:ext>
                </a:extLst>
              </p:cNvPr>
              <p:cNvSpPr/>
              <p:nvPr/>
            </p:nvSpPr>
            <p:spPr>
              <a:xfrm>
                <a:off x="8111518" y="3132069"/>
                <a:ext cx="294595" cy="222422"/>
              </a:xfrm>
              <a:prstGeom prst="lef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FC3F2A0-3295-CF6F-7D9E-9C78778DF362}"/>
                  </a:ext>
                </a:extLst>
              </p:cNvPr>
              <p:cNvSpPr txBox="1"/>
              <p:nvPr/>
            </p:nvSpPr>
            <p:spPr>
              <a:xfrm>
                <a:off x="8358809" y="3039404"/>
                <a:ext cx="69466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solidFill>
                      <a:srgbClr val="800080"/>
                    </a:solidFill>
                  </a:rPr>
                  <a:t>MZB</a:t>
                </a:r>
              </a:p>
            </p:txBody>
          </p:sp>
          <p:sp>
            <p:nvSpPr>
              <p:cNvPr id="26" name="Arrow: Left 25">
                <a:extLst>
                  <a:ext uri="{FF2B5EF4-FFF2-40B4-BE49-F238E27FC236}">
                    <a16:creationId xmlns:a16="http://schemas.microsoft.com/office/drawing/2014/main" id="{EA48A928-517C-A02B-7B68-27D1A10139BB}"/>
                  </a:ext>
                </a:extLst>
              </p:cNvPr>
              <p:cNvSpPr/>
              <p:nvPr/>
            </p:nvSpPr>
            <p:spPr>
              <a:xfrm>
                <a:off x="3386200" y="5559471"/>
                <a:ext cx="294595" cy="222422"/>
              </a:xfrm>
              <a:prstGeom prst="left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31BFD04-E8F4-0161-6126-B8F2A06D10A7}"/>
                  </a:ext>
                </a:extLst>
              </p:cNvPr>
              <p:cNvSpPr txBox="1"/>
              <p:nvPr/>
            </p:nvSpPr>
            <p:spPr>
              <a:xfrm>
                <a:off x="3657698" y="5467820"/>
                <a:ext cx="85675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solidFill>
                      <a:srgbClr val="008000"/>
                    </a:solidFill>
                  </a:rPr>
                  <a:t>Naive</a:t>
                </a:r>
              </a:p>
            </p:txBody>
          </p: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1B71568B-D604-6846-0406-BF4D1B07F6C0}"/>
                  </a:ext>
                </a:extLst>
              </p:cNvPr>
              <p:cNvGrpSpPr/>
              <p:nvPr/>
            </p:nvGrpSpPr>
            <p:grpSpPr>
              <a:xfrm>
                <a:off x="38865" y="2811742"/>
                <a:ext cx="2153193" cy="2020821"/>
                <a:chOff x="1704823" y="657270"/>
                <a:chExt cx="2153193" cy="2020821"/>
              </a:xfrm>
            </p:grpSpPr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F81D5311-BD32-4A1C-3B56-8E61042ABE1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970680" y="657270"/>
                  <a:ext cx="1887336" cy="1755046"/>
                </a:xfrm>
                <a:prstGeom prst="rect">
                  <a:avLst/>
                </a:prstGeom>
              </p:spPr>
            </p:pic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168C7F36-2128-5BAF-E234-45DA6659F07D}"/>
                    </a:ext>
                  </a:extLst>
                </p:cNvPr>
                <p:cNvSpPr txBox="1"/>
                <p:nvPr/>
              </p:nvSpPr>
              <p:spPr>
                <a:xfrm rot="16200000">
                  <a:off x="1482601" y="1544391"/>
                  <a:ext cx="78299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VD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F4F76049-9B81-3967-E69D-682D601A1AD0}"/>
                    </a:ext>
                  </a:extLst>
                </p:cNvPr>
                <p:cNvSpPr txBox="1"/>
                <p:nvPr/>
              </p:nvSpPr>
              <p:spPr>
                <a:xfrm>
                  <a:off x="2265381" y="2339537"/>
                  <a:ext cx="74965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9</a:t>
                  </a:r>
                </a:p>
              </p:txBody>
            </p:sp>
          </p:grp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76860ACB-F8A4-1D99-7325-4858BF5033F9}"/>
                  </a:ext>
                </a:extLst>
              </p:cNvPr>
              <p:cNvSpPr txBox="1"/>
              <p:nvPr/>
            </p:nvSpPr>
            <p:spPr>
              <a:xfrm rot="16200000">
                <a:off x="1974893" y="3687927"/>
                <a:ext cx="7829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7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1A832E3-C3F4-FA0C-DBCC-499D5A2B661E}"/>
                  </a:ext>
                </a:extLst>
              </p:cNvPr>
              <p:cNvSpPr txBox="1"/>
              <p:nvPr/>
            </p:nvSpPr>
            <p:spPr>
              <a:xfrm>
                <a:off x="2609389" y="4483073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8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A69389F-3F1D-B2F2-CC03-B709E42407DA}"/>
                  </a:ext>
                </a:extLst>
              </p:cNvPr>
              <p:cNvSpPr txBox="1"/>
              <p:nvPr/>
            </p:nvSpPr>
            <p:spPr>
              <a:xfrm rot="16200000">
                <a:off x="1876037" y="5762854"/>
                <a:ext cx="7829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A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AB3D5F6-E34C-2F60-EB74-70065A24B1D5}"/>
                  </a:ext>
                </a:extLst>
              </p:cNvPr>
              <p:cNvSpPr txBox="1"/>
              <p:nvPr/>
            </p:nvSpPr>
            <p:spPr>
              <a:xfrm>
                <a:off x="2696395" y="6532948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G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F69BA7B-9E6F-E813-8ADA-BB4F5AFD49DA}"/>
                  </a:ext>
                </a:extLst>
              </p:cNvPr>
              <p:cNvSpPr txBox="1"/>
              <p:nvPr/>
            </p:nvSpPr>
            <p:spPr>
              <a:xfrm rot="16200000">
                <a:off x="4067308" y="3729119"/>
                <a:ext cx="7829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A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B635EE8F-6BF2-AB81-746B-E5EB19CC8242}"/>
                  </a:ext>
                </a:extLst>
              </p:cNvPr>
              <p:cNvSpPr txBox="1"/>
              <p:nvPr/>
            </p:nvSpPr>
            <p:spPr>
              <a:xfrm>
                <a:off x="4850088" y="4524265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G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E9960A0B-5998-ED7B-9E70-E0A30280F9C8}"/>
                  </a:ext>
                </a:extLst>
              </p:cNvPr>
              <p:cNvSpPr txBox="1"/>
              <p:nvPr/>
            </p:nvSpPr>
            <p:spPr>
              <a:xfrm rot="16200000">
                <a:off x="6302706" y="3667333"/>
                <a:ext cx="7829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c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4D5E162-FC7A-2A92-25DE-AEFF8ACE47AE}"/>
                  </a:ext>
                </a:extLst>
              </p:cNvPr>
              <p:cNvSpPr txBox="1"/>
              <p:nvPr/>
            </p:nvSpPr>
            <p:spPr>
              <a:xfrm>
                <a:off x="7085486" y="4462479"/>
                <a:ext cx="7496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7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6A3A3AE8-2CFA-AABA-3CB0-A46C4088F6EB}"/>
                  </a:ext>
                </a:extLst>
              </p:cNvPr>
              <p:cNvSpPr txBox="1"/>
              <p:nvPr/>
            </p:nvSpPr>
            <p:spPr>
              <a:xfrm>
                <a:off x="4451652" y="5235373"/>
                <a:ext cx="914392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CD19+</a:t>
                </a:r>
              </a:p>
              <a:p>
                <a:r>
                  <a:rPr lang="en-US" sz="1000" b="1" dirty="0"/>
                  <a:t>IgA-</a:t>
                </a:r>
              </a:p>
              <a:p>
                <a:r>
                  <a:rPr lang="en-US" sz="1000" b="1" dirty="0"/>
                  <a:t>IgG-</a:t>
                </a:r>
              </a:p>
              <a:p>
                <a:r>
                  <a:rPr lang="en-US" sz="1000" b="1" dirty="0"/>
                  <a:t>CD38 Int</a:t>
                </a:r>
              </a:p>
              <a:p>
                <a:r>
                  <a:rPr lang="en-US" sz="1000" b="1" dirty="0"/>
                  <a:t>CD27-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CC9BFC02-EFC3-2FDF-7D99-433BD1FBA019}"/>
                  </a:ext>
                </a:extLst>
              </p:cNvPr>
              <p:cNvSpPr txBox="1"/>
              <p:nvPr/>
            </p:nvSpPr>
            <p:spPr>
              <a:xfrm>
                <a:off x="7747252" y="4727930"/>
                <a:ext cx="1221383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CD19+        IgG-</a:t>
                </a:r>
              </a:p>
              <a:p>
                <a:r>
                  <a:rPr lang="en-US" sz="1000" b="1" dirty="0"/>
                  <a:t>CD27+        IgA-</a:t>
                </a:r>
              </a:p>
              <a:p>
                <a:r>
                  <a:rPr lang="en-US" sz="1000" b="1" dirty="0"/>
                  <a:t>CD1c+         CD38 Int</a:t>
                </a:r>
              </a:p>
            </p:txBody>
          </p:sp>
          <p:cxnSp>
            <p:nvCxnSpPr>
              <p:cNvPr id="42" name="Straight Arrow Connector 41">
                <a:extLst>
                  <a:ext uri="{FF2B5EF4-FFF2-40B4-BE49-F238E27FC236}">
                    <a16:creationId xmlns:a16="http://schemas.microsoft.com/office/drawing/2014/main" id="{30B60E86-1361-3D13-2E6D-511E99725D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3797" y="3622222"/>
                <a:ext cx="1655806" cy="0"/>
              </a:xfrm>
              <a:prstGeom prst="straightConnector1">
                <a:avLst/>
              </a:prstGeom>
              <a:ln w="3492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59F4815B-420D-E8A8-C571-D5B8A957105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419943" y="4911452"/>
                <a:ext cx="1655806" cy="0"/>
              </a:xfrm>
              <a:prstGeom prst="straightConnector1">
                <a:avLst/>
              </a:prstGeom>
              <a:ln w="3492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Arrow: Down 43">
                <a:extLst>
                  <a:ext uri="{FF2B5EF4-FFF2-40B4-BE49-F238E27FC236}">
                    <a16:creationId xmlns:a16="http://schemas.microsoft.com/office/drawing/2014/main" id="{2359F686-CDEE-BF9C-4494-90D9B22DBCE8}"/>
                  </a:ext>
                </a:extLst>
              </p:cNvPr>
              <p:cNvSpPr/>
              <p:nvPr/>
            </p:nvSpPr>
            <p:spPr>
              <a:xfrm rot="16200000">
                <a:off x="1893798" y="3726149"/>
                <a:ext cx="210065" cy="383060"/>
              </a:xfrm>
              <a:prstGeom prst="downArrow">
                <a:avLst/>
              </a:prstGeom>
              <a:solidFill>
                <a:srgbClr val="FFC000"/>
              </a:solidFill>
              <a:ln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FBD6410-4737-A00C-599F-F8014ED9E1C2}"/>
                  </a:ext>
                </a:extLst>
              </p:cNvPr>
              <p:cNvSpPr txBox="1"/>
              <p:nvPr/>
            </p:nvSpPr>
            <p:spPr>
              <a:xfrm>
                <a:off x="50107" y="2517729"/>
                <a:ext cx="47598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22166431-FA44-B7B4-F7B5-3A8022CC76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59837" y="3561680"/>
                <a:ext cx="1655806" cy="0"/>
              </a:xfrm>
              <a:prstGeom prst="straightConnector1">
                <a:avLst/>
              </a:prstGeom>
              <a:ln w="3492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2686865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BDA8E3B-2CEC-3507-B90E-A4294FB8C1DA}"/>
              </a:ext>
            </a:extLst>
          </p:cNvPr>
          <p:cNvGrpSpPr/>
          <p:nvPr/>
        </p:nvGrpSpPr>
        <p:grpSpPr>
          <a:xfrm>
            <a:off x="-176" y="-40695"/>
            <a:ext cx="9091725" cy="6788187"/>
            <a:chOff x="-176" y="-40695"/>
            <a:chExt cx="9091725" cy="678818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D5AEEDD-DDA1-2C86-7B6C-EC5B6E930E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464"/>
            <a:stretch/>
          </p:blipFill>
          <p:spPr>
            <a:xfrm>
              <a:off x="415887" y="375935"/>
              <a:ext cx="1969773" cy="175754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21517F3-8067-B644-579E-A1FFD90F54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136" b="-1"/>
            <a:stretch/>
          </p:blipFill>
          <p:spPr>
            <a:xfrm>
              <a:off x="2753834" y="356203"/>
              <a:ext cx="1838443" cy="172435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5D7EAC0-3D59-24D5-2B46-7411EBA385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80123" y="375780"/>
              <a:ext cx="1867484" cy="171606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3715217-998D-900C-048E-26DAE87E2248}"/>
                </a:ext>
              </a:extLst>
            </p:cNvPr>
            <p:cNvSpPr txBox="1"/>
            <p:nvPr/>
          </p:nvSpPr>
          <p:spPr>
            <a:xfrm rot="16200000">
              <a:off x="-70623" y="895901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VD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7716ADD-2C8B-8E91-4639-489433C5E593}"/>
                </a:ext>
              </a:extLst>
            </p:cNvPr>
            <p:cNvSpPr txBox="1"/>
            <p:nvPr/>
          </p:nvSpPr>
          <p:spPr>
            <a:xfrm>
              <a:off x="1200671" y="2051439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E810DC4-7663-2C3F-1AFF-CCE8E952E220}"/>
                </a:ext>
              </a:extLst>
            </p:cNvPr>
            <p:cNvSpPr txBox="1"/>
            <p:nvPr/>
          </p:nvSpPr>
          <p:spPr>
            <a:xfrm rot="16200000">
              <a:off x="2200361" y="884965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24C91FE-D2C2-8623-9016-414948F9A387}"/>
                </a:ext>
              </a:extLst>
            </p:cNvPr>
            <p:cNvSpPr txBox="1"/>
            <p:nvPr/>
          </p:nvSpPr>
          <p:spPr>
            <a:xfrm>
              <a:off x="3448631" y="2027977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0A8008C-6995-1AF2-F717-DE7ED99BE1B8}"/>
                </a:ext>
              </a:extLst>
            </p:cNvPr>
            <p:cNvSpPr txBox="1"/>
            <p:nvPr/>
          </p:nvSpPr>
          <p:spPr>
            <a:xfrm rot="16200000">
              <a:off x="4557592" y="872243"/>
              <a:ext cx="5741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g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6134021-E82C-5406-D4DF-DC06130E73D6}"/>
                </a:ext>
              </a:extLst>
            </p:cNvPr>
            <p:cNvSpPr txBox="1"/>
            <p:nvPr/>
          </p:nvSpPr>
          <p:spPr>
            <a:xfrm>
              <a:off x="5877999" y="1998536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E5406EC-FCCE-01F6-B264-4D94B44C462D}"/>
                </a:ext>
              </a:extLst>
            </p:cNvPr>
            <p:cNvSpPr txBox="1"/>
            <p:nvPr/>
          </p:nvSpPr>
          <p:spPr>
            <a:xfrm>
              <a:off x="12529" y="250523"/>
              <a:ext cx="4759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C913BCE-1884-539D-9BC1-8BA039C9D3E1}"/>
                </a:ext>
              </a:extLst>
            </p:cNvPr>
            <p:cNvSpPr txBox="1"/>
            <p:nvPr/>
          </p:nvSpPr>
          <p:spPr>
            <a:xfrm>
              <a:off x="14617" y="2269297"/>
              <a:ext cx="4759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D20EE6E-242F-AD0B-DADD-D421568A61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769"/>
            <a:stretch/>
          </p:blipFill>
          <p:spPr>
            <a:xfrm>
              <a:off x="428937" y="2379946"/>
              <a:ext cx="1954485" cy="175893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32842416-242F-5A30-FCBC-0A86A94875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6114"/>
            <a:stretch/>
          </p:blipFill>
          <p:spPr>
            <a:xfrm>
              <a:off x="2687677" y="2392471"/>
              <a:ext cx="1914792" cy="1735115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9FA93A7-F6CD-44A2-234F-C2286B180C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6792"/>
            <a:stretch/>
          </p:blipFill>
          <p:spPr>
            <a:xfrm>
              <a:off x="4915546" y="2379945"/>
              <a:ext cx="1943371" cy="1760167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B1A4C36D-A9B1-81E4-8B6C-042B964DE6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9658"/>
            <a:stretch/>
          </p:blipFill>
          <p:spPr>
            <a:xfrm>
              <a:off x="7167230" y="2392471"/>
              <a:ext cx="1924319" cy="1741641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126597E-08CB-1444-456A-237B1618A2A7}"/>
                </a:ext>
              </a:extLst>
            </p:cNvPr>
            <p:cNvSpPr txBox="1"/>
            <p:nvPr/>
          </p:nvSpPr>
          <p:spPr>
            <a:xfrm rot="16200000">
              <a:off x="-118639" y="2964779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V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73564FC-CA25-FD45-05EA-C825ACDFF76B}"/>
                </a:ext>
              </a:extLst>
            </p:cNvPr>
            <p:cNvSpPr txBox="1"/>
            <p:nvPr/>
          </p:nvSpPr>
          <p:spPr>
            <a:xfrm>
              <a:off x="1152655" y="4095265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F2DDB82-2A2F-946E-62C9-7A644A401B8F}"/>
                </a:ext>
              </a:extLst>
            </p:cNvPr>
            <p:cNvSpPr txBox="1"/>
            <p:nvPr/>
          </p:nvSpPr>
          <p:spPr>
            <a:xfrm rot="16200000">
              <a:off x="2202449" y="2891213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0AF0DE3-8DC5-7EF8-B931-A6DE9D505DFB}"/>
                </a:ext>
              </a:extLst>
            </p:cNvPr>
            <p:cNvSpPr txBox="1"/>
            <p:nvPr/>
          </p:nvSpPr>
          <p:spPr>
            <a:xfrm>
              <a:off x="3388089" y="4071803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8DAEB77-9978-C6C8-AEDF-99565D3A387A}"/>
                </a:ext>
              </a:extLst>
            </p:cNvPr>
            <p:cNvSpPr txBox="1"/>
            <p:nvPr/>
          </p:nvSpPr>
          <p:spPr>
            <a:xfrm rot="16200000">
              <a:off x="4408377" y="2836720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g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BDE368B-5A17-DADC-AD0E-51362FC25B0E}"/>
                </a:ext>
              </a:extLst>
            </p:cNvPr>
            <p:cNvSpPr txBox="1"/>
            <p:nvPr/>
          </p:nvSpPr>
          <p:spPr>
            <a:xfrm>
              <a:off x="5804931" y="4054888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2F0470B-7929-83DC-E067-BCD942545AC0}"/>
                </a:ext>
              </a:extLst>
            </p:cNvPr>
            <p:cNvSpPr txBox="1"/>
            <p:nvPr/>
          </p:nvSpPr>
          <p:spPr>
            <a:xfrm rot="16200000">
              <a:off x="6653434" y="2931161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1c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18AF19D-4449-2F1E-E7C1-BAF3BBF3C792}"/>
                </a:ext>
              </a:extLst>
            </p:cNvPr>
            <p:cNvSpPr txBox="1"/>
            <p:nvPr/>
          </p:nvSpPr>
          <p:spPr>
            <a:xfrm>
              <a:off x="7924728" y="4086699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80BBF0F-D29D-175F-6513-750D8B83ABE2}"/>
                </a:ext>
              </a:extLst>
            </p:cNvPr>
            <p:cNvSpPr txBox="1"/>
            <p:nvPr/>
          </p:nvSpPr>
          <p:spPr>
            <a:xfrm>
              <a:off x="4179" y="4463435"/>
              <a:ext cx="4759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1901E17A-6E92-5E6A-B20F-27D729F19C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8177"/>
            <a:stretch/>
          </p:blipFill>
          <p:spPr>
            <a:xfrm>
              <a:off x="352020" y="4584526"/>
              <a:ext cx="2076740" cy="1863192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BB97C032-190F-6F76-CBAD-8B7CD2D340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9451"/>
            <a:stretch/>
          </p:blipFill>
          <p:spPr>
            <a:xfrm>
              <a:off x="2664389" y="4584526"/>
              <a:ext cx="1995293" cy="1828800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CB2FB290-B6ED-8CE2-A4A0-5DDC8F92A3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8538"/>
            <a:stretch/>
          </p:blipFill>
          <p:spPr>
            <a:xfrm>
              <a:off x="4937598" y="4588610"/>
              <a:ext cx="1989295" cy="1824716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1A4F026-FBCF-AB49-94E0-5DA4B87A38F0}"/>
                </a:ext>
              </a:extLst>
            </p:cNvPr>
            <p:cNvSpPr txBox="1"/>
            <p:nvPr/>
          </p:nvSpPr>
          <p:spPr>
            <a:xfrm rot="16200000">
              <a:off x="-204233" y="5108813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VD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DF4A77E-3722-509E-6A6B-6E808EC9C1A1}"/>
                </a:ext>
              </a:extLst>
            </p:cNvPr>
            <p:cNvSpPr txBox="1"/>
            <p:nvPr/>
          </p:nvSpPr>
          <p:spPr>
            <a:xfrm>
              <a:off x="1054535" y="6439715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3361DFC-361C-4490-21A9-74303780DBCC}"/>
                </a:ext>
              </a:extLst>
            </p:cNvPr>
            <p:cNvSpPr txBox="1"/>
            <p:nvPr/>
          </p:nvSpPr>
          <p:spPr>
            <a:xfrm rot="16200000">
              <a:off x="2154433" y="5122929"/>
              <a:ext cx="782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DC08C68-3354-087B-037F-3DACE686DF87}"/>
                </a:ext>
              </a:extLst>
            </p:cNvPr>
            <p:cNvSpPr txBox="1"/>
            <p:nvPr/>
          </p:nvSpPr>
          <p:spPr>
            <a:xfrm>
              <a:off x="3302495" y="6391201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0B85959-0858-65E6-C149-3C6C6A4F0289}"/>
                </a:ext>
              </a:extLst>
            </p:cNvPr>
            <p:cNvSpPr txBox="1"/>
            <p:nvPr/>
          </p:nvSpPr>
          <p:spPr>
            <a:xfrm rot="16200000">
              <a:off x="4477846" y="5079235"/>
              <a:ext cx="6875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g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8F5E0ED-160A-FFA7-1488-1B10919A5248}"/>
                </a:ext>
              </a:extLst>
            </p:cNvPr>
            <p:cNvSpPr txBox="1"/>
            <p:nvPr/>
          </p:nvSpPr>
          <p:spPr>
            <a:xfrm>
              <a:off x="5799592" y="6361060"/>
              <a:ext cx="74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4A21C9B-F2B3-047D-F1CF-B06A5F0D654E}"/>
                </a:ext>
              </a:extLst>
            </p:cNvPr>
            <p:cNvSpPr txBox="1"/>
            <p:nvPr/>
          </p:nvSpPr>
          <p:spPr>
            <a:xfrm>
              <a:off x="8246075" y="2626046"/>
              <a:ext cx="584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800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ZB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41577B8-B102-010A-8C0C-E7BE04330295}"/>
                </a:ext>
              </a:extLst>
            </p:cNvPr>
            <p:cNvSpPr txBox="1"/>
            <p:nvPr/>
          </p:nvSpPr>
          <p:spPr>
            <a:xfrm>
              <a:off x="5956398" y="5272681"/>
              <a:ext cx="9830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 Mem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F7037B7-5B3E-3DF9-8D2C-293B8E1FE78D}"/>
                </a:ext>
              </a:extLst>
            </p:cNvPr>
            <p:cNvSpPr txBox="1"/>
            <p:nvPr/>
          </p:nvSpPr>
          <p:spPr>
            <a:xfrm>
              <a:off x="5887326" y="1046142"/>
              <a:ext cx="6888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ACE0863-776E-87D2-7685-8E311CDEB27D}"/>
                </a:ext>
              </a:extLst>
            </p:cNvPr>
            <p:cNvSpPr txBox="1"/>
            <p:nvPr/>
          </p:nvSpPr>
          <p:spPr>
            <a:xfrm>
              <a:off x="-176" y="-40695"/>
              <a:ext cx="238012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800"/>
                </a:spcAft>
              </a:pPr>
              <a:r>
                <a:rPr lang="en-US" sz="16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l </a:t>
              </a:r>
              <a:r>
                <a:rPr lang="en-US" sz="1600" b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</a:t>
              </a:r>
              <a:r>
                <a:rPr lang="en-US" sz="16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g. 2</a:t>
              </a:r>
              <a:endPara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64956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55</TotalTime>
  <Words>82</Words>
  <Application>Microsoft Office PowerPoint</Application>
  <PresentationFormat>On-screen Show (4:3)</PresentationFormat>
  <Paragraphs>6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que, Shabirul</dc:creator>
  <cp:lastModifiedBy>Haque, Shabirul</cp:lastModifiedBy>
  <cp:revision>326</cp:revision>
  <cp:lastPrinted>2024-07-16T16:10:26Z</cp:lastPrinted>
  <dcterms:created xsi:type="dcterms:W3CDTF">2023-07-21T13:33:01Z</dcterms:created>
  <dcterms:modified xsi:type="dcterms:W3CDTF">2024-12-13T18:35:13Z</dcterms:modified>
</cp:coreProperties>
</file>